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AEDFF1-02F7-40DC-8779-C24C5F577FC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CE2C61-5178-4F30-BEB2-C2D8A2CD489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15A01D-A209-40C9-A12C-3947E77BCFD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E7AC13-DC68-4933-8B84-58631F5458B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01986E-C744-4509-8B80-52BD3C7A738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6B66FF-6C63-4ECB-97C4-6BC425F8CF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4CFF3A-156E-4607-9AAF-CB5FD06D5F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E82071-25EA-41DF-B4AB-DB320B8BDA0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A2D7DB-4486-4208-A3DF-AD4104105E1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CA32BC-71B8-4165-A5FC-DBFD627033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13BF69-9E03-4B1E-92C0-6B4513A9F2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B699E3-F65A-4675-92CA-C608600100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B19BFB4-6918-402A-ADA9-FCCB5B1FEE70}" type="datetime">
              <a:rPr b="0" lang="zh-CN" sz="1200" spc="-1" strike="noStrike">
                <a:solidFill>
                  <a:srgbClr val="898989"/>
                </a:solidFill>
                <a:latin typeface="Calibri"/>
              </a:rPr>
              <a:t>26/8/29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9D96C04-FADE-4DC1-A7E0-586ADEDE5926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直线连接符 23"/>
          <p:cNvSpPr/>
          <p:nvPr/>
        </p:nvSpPr>
        <p:spPr>
          <a:xfrm>
            <a:off x="1488960" y="4335480"/>
            <a:ext cx="5688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直线连接符 24"/>
          <p:cNvSpPr/>
          <p:nvPr/>
        </p:nvSpPr>
        <p:spPr>
          <a:xfrm>
            <a:off x="1488960" y="2014560"/>
            <a:ext cx="5688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文本框 63"/>
          <p:cNvSpPr/>
          <p:nvPr/>
        </p:nvSpPr>
        <p:spPr>
          <a:xfrm>
            <a:off x="3844800" y="2076480"/>
            <a:ext cx="12398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Volume (uL)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文本框 14"/>
          <p:cNvSpPr/>
          <p:nvPr/>
        </p:nvSpPr>
        <p:spPr>
          <a:xfrm>
            <a:off x="1649520" y="2600280"/>
            <a:ext cx="9111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2XPfu Mix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矩形 15"/>
          <p:cNvSpPr/>
          <p:nvPr/>
        </p:nvSpPr>
        <p:spPr>
          <a:xfrm>
            <a:off x="5560920" y="2076480"/>
            <a:ext cx="16210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Final concentratio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文本框 65"/>
          <p:cNvSpPr/>
          <p:nvPr/>
        </p:nvSpPr>
        <p:spPr>
          <a:xfrm>
            <a:off x="2151000" y="1604880"/>
            <a:ext cx="43624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SUPPLEMENTARY TABLE 11  </a:t>
            </a: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  RT-PCR reaction system (50 uL)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文本框 6"/>
          <p:cNvSpPr/>
          <p:nvPr/>
        </p:nvSpPr>
        <p:spPr>
          <a:xfrm>
            <a:off x="1644480" y="2076480"/>
            <a:ext cx="10195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Component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文本框 7"/>
          <p:cNvSpPr/>
          <p:nvPr/>
        </p:nvSpPr>
        <p:spPr>
          <a:xfrm>
            <a:off x="1649520" y="2933640"/>
            <a:ext cx="12794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cDNA template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文本框 8"/>
          <p:cNvSpPr/>
          <p:nvPr/>
        </p:nvSpPr>
        <p:spPr>
          <a:xfrm>
            <a:off x="1649520" y="3267000"/>
            <a:ext cx="18237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Forward primer (10 uM)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文本框 9"/>
          <p:cNvSpPr/>
          <p:nvPr/>
        </p:nvSpPr>
        <p:spPr>
          <a:xfrm>
            <a:off x="1649520" y="3641760"/>
            <a:ext cx="18716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Reverse primer (10 uM)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文本框 5"/>
          <p:cNvSpPr/>
          <p:nvPr/>
        </p:nvSpPr>
        <p:spPr>
          <a:xfrm>
            <a:off x="6099120" y="2602800"/>
            <a:ext cx="7207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1X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文本框 13"/>
          <p:cNvSpPr/>
          <p:nvPr/>
        </p:nvSpPr>
        <p:spPr>
          <a:xfrm>
            <a:off x="6099120" y="2908440"/>
            <a:ext cx="7207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 baseline="30000">
                <a:solidFill>
                  <a:srgbClr val="000000"/>
                </a:solidFill>
                <a:latin typeface="Calibri"/>
                <a:ea typeface="微软雅黑"/>
              </a:rPr>
              <a:t>___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文本框 22"/>
          <p:cNvSpPr/>
          <p:nvPr/>
        </p:nvSpPr>
        <p:spPr>
          <a:xfrm>
            <a:off x="6099120" y="3270960"/>
            <a:ext cx="7207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0.4 </a:t>
            </a:r>
            <a:r>
              <a:rPr b="0" lang="zh-CN" sz="1300" spc="-1" strike="noStrike">
                <a:solidFill>
                  <a:srgbClr val="000000"/>
                </a:solidFill>
                <a:latin typeface="Calibri"/>
              </a:rPr>
              <a:t>μ</a:t>
            </a: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M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文本框 30"/>
          <p:cNvSpPr/>
          <p:nvPr/>
        </p:nvSpPr>
        <p:spPr>
          <a:xfrm>
            <a:off x="6099120" y="3597480"/>
            <a:ext cx="72072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0.4 </a:t>
            </a:r>
            <a:r>
              <a:rPr b="0" lang="zh-CN" sz="1300" spc="-1" strike="noStrike">
                <a:solidFill>
                  <a:srgbClr val="000000"/>
                </a:solidFill>
                <a:latin typeface="Calibri"/>
              </a:rPr>
              <a:t>μ</a:t>
            </a: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M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文本框 31"/>
          <p:cNvSpPr/>
          <p:nvPr/>
        </p:nvSpPr>
        <p:spPr>
          <a:xfrm>
            <a:off x="6099120" y="4034880"/>
            <a:ext cx="7207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 baseline="30000">
                <a:solidFill>
                  <a:srgbClr val="000000"/>
                </a:solidFill>
                <a:latin typeface="Calibri"/>
                <a:ea typeface="微软雅黑"/>
              </a:rPr>
              <a:t>___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文本框 67"/>
          <p:cNvSpPr/>
          <p:nvPr/>
        </p:nvSpPr>
        <p:spPr>
          <a:xfrm>
            <a:off x="4189320" y="2598840"/>
            <a:ext cx="7207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25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文本框 71"/>
          <p:cNvSpPr/>
          <p:nvPr/>
        </p:nvSpPr>
        <p:spPr>
          <a:xfrm>
            <a:off x="4189320" y="2870280"/>
            <a:ext cx="720720" cy="36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1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文本框 72"/>
          <p:cNvSpPr/>
          <p:nvPr/>
        </p:nvSpPr>
        <p:spPr>
          <a:xfrm>
            <a:off x="4189320" y="3267000"/>
            <a:ext cx="7207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2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文本框 73"/>
          <p:cNvSpPr/>
          <p:nvPr/>
        </p:nvSpPr>
        <p:spPr>
          <a:xfrm>
            <a:off x="4189320" y="3641760"/>
            <a:ext cx="7207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2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文本框 87"/>
          <p:cNvSpPr/>
          <p:nvPr/>
        </p:nvSpPr>
        <p:spPr>
          <a:xfrm>
            <a:off x="1406520" y="4363920"/>
            <a:ext cx="62643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Note: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MiniRT-F and ABO-RT-R were used as forward and reverse primers at a working concentration of 10 uMcDNA input may be adjusted according to concentration but generally should not exceed 10% of the total reactionvolume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直线连接符 1"/>
          <p:cNvSpPr/>
          <p:nvPr/>
        </p:nvSpPr>
        <p:spPr>
          <a:xfrm>
            <a:off x="1488960" y="2467080"/>
            <a:ext cx="5688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文本框 58"/>
          <p:cNvSpPr/>
          <p:nvPr/>
        </p:nvSpPr>
        <p:spPr>
          <a:xfrm>
            <a:off x="1649520" y="3995640"/>
            <a:ext cx="801720" cy="318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ddH</a:t>
            </a:r>
            <a:r>
              <a:rPr b="0" lang="en-US" sz="1300" spc="-1" strike="noStrike" baseline="-25000">
                <a:solidFill>
                  <a:srgbClr val="000000"/>
                </a:solidFill>
                <a:latin typeface="Calibri"/>
                <a:ea typeface="微软雅黑"/>
              </a:rPr>
              <a:t>2</a:t>
            </a: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O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文本框 59"/>
          <p:cNvSpPr/>
          <p:nvPr/>
        </p:nvSpPr>
        <p:spPr>
          <a:xfrm>
            <a:off x="4189320" y="3995640"/>
            <a:ext cx="8953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Up to 50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8-09T12:44:00Z</dcterms:created>
  <dc:creator>ghl</dc:creator>
  <dc:description/>
  <dc:language>en-US</dc:language>
  <cp:lastModifiedBy>墨铁</cp:lastModifiedBy>
  <dcterms:modified xsi:type="dcterms:W3CDTF">2026-05-25T09:47:30Z</dcterms:modified>
  <cp:revision>57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4EF8A1A72F364BE3A5218373BDAA2C6E_13</vt:lpwstr>
  </property>
  <property fmtid="{D5CDD505-2E9C-101B-9397-08002B2CF9AE}" pid="3" name="KSOProductBuildVer">
    <vt:lpwstr>2052-12.1.0.26375</vt:lpwstr>
  </property>
</Properties>
</file>